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D6B98-4504-4797-92CA-551ED079C8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F18D2-4905-4DDD-98D7-709A3B7571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3FAB9-24E5-4F3A-A95A-C7505EE580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F0EB5-D97E-4207-AFF6-0D0C84F2AC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A4554-9A5C-42D1-93BF-399995E55D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1BAEE4-5BE0-4423-B200-C636DEA8EB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71329-DA3D-4196-978A-19896A8ED0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8CDCD-75FE-4DD4-9DC6-8181363834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1EB08-381C-420C-BE6D-F7DCB5743F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279A13-6810-4A16-8C99-EC3580499B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93D233-240B-4216-B882-96B3DAD1E5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CED17-19CD-413C-A2A2-A3B2F08A69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817B7E-4A5E-4196-B9B2-3BC7C1626C4D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4267080" y="1066680"/>
            <a:ext cx="3060720" cy="13716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090440" y="1066680"/>
            <a:ext cx="3024360" cy="137160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5800680" y="1257480"/>
            <a:ext cx="15228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flipH="1">
            <a:off x="6190920" y="2066760"/>
            <a:ext cx="15228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093680" y="2138400"/>
            <a:ext cx="30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275000" y="2147760"/>
            <a:ext cx="30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074600" y="2678040"/>
            <a:ext cx="622800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3: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CG2604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</a:rPr>
              <a:t>EY05974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is a hypomorphic mutation. 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Wild type wing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Wing of a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G2604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EY0597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f(3R)ED5147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ly, ectopic wing veins are indicated by arrow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028880" y="1009800"/>
            <a:ext cx="6352920" cy="1476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09T08:13:09Z</dcterms:created>
  <dc:creator>Revital Bronstien</dc:creator>
  <dc:description/>
  <dc:language>en-US</dc:language>
  <cp:lastModifiedBy>Revital Bronstien</cp:lastModifiedBy>
  <dcterms:modified xsi:type="dcterms:W3CDTF">2010-06-28T08:07:33Z</dcterms:modified>
  <cp:revision>3</cp:revision>
  <dc:subject/>
  <dc:title>שקופית 1</dc:title>
</cp:coreProperties>
</file>